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404" r:id="rId2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  <a:srgbClr val="00CC00"/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C7853C-536D-4A76-A0AE-DD22124D55A5}" styleName="テーマ スタイル 1 - アクセント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69" autoAdjust="0"/>
    <p:restoredTop sz="94954" autoAdjust="0"/>
  </p:normalViewPr>
  <p:slideViewPr>
    <p:cSldViewPr snapToGrid="0">
      <p:cViewPr varScale="1">
        <p:scale>
          <a:sx n="74" d="100"/>
          <a:sy n="74" d="100"/>
        </p:scale>
        <p:origin x="1642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5" y="3"/>
            <a:ext cx="2949786" cy="498693"/>
          </a:xfrm>
          <a:prstGeom prst="rect">
            <a:avLst/>
          </a:prstGeom>
        </p:spPr>
        <p:txBody>
          <a:bodyPr vert="horz" lIns="95624" tIns="47814" rIns="95624" bIns="47814" rtlCol="0"/>
          <a:lstStyle>
            <a:lvl1pPr algn="l">
              <a:defRPr sz="13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5844" y="3"/>
            <a:ext cx="2949786" cy="498693"/>
          </a:xfrm>
          <a:prstGeom prst="rect">
            <a:avLst/>
          </a:prstGeom>
        </p:spPr>
        <p:txBody>
          <a:bodyPr vert="horz" lIns="95624" tIns="47814" rIns="95624" bIns="47814" rtlCol="0"/>
          <a:lstStyle>
            <a:lvl1pPr algn="r">
              <a:defRPr sz="1300"/>
            </a:lvl1pPr>
          </a:lstStyle>
          <a:p>
            <a:fld id="{77AA9483-565E-46D9-A842-79CD4DF778D0}" type="datetimeFigureOut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5" y="9440648"/>
            <a:ext cx="2949786" cy="498692"/>
          </a:xfrm>
          <a:prstGeom prst="rect">
            <a:avLst/>
          </a:prstGeom>
        </p:spPr>
        <p:txBody>
          <a:bodyPr vert="horz" lIns="95624" tIns="47814" rIns="95624" bIns="47814" rtlCol="0" anchor="b"/>
          <a:lstStyle>
            <a:lvl1pPr algn="l">
              <a:defRPr sz="1300"/>
            </a:lvl1pPr>
          </a:lstStyle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5844" y="9440648"/>
            <a:ext cx="2949786" cy="498692"/>
          </a:xfrm>
          <a:prstGeom prst="rect">
            <a:avLst/>
          </a:prstGeom>
        </p:spPr>
        <p:txBody>
          <a:bodyPr vert="horz" lIns="95624" tIns="47814" rIns="95624" bIns="47814" rtlCol="0" anchor="b"/>
          <a:lstStyle>
            <a:lvl1pPr algn="r">
              <a:defRPr sz="1300"/>
            </a:lvl1pPr>
          </a:lstStyle>
          <a:p>
            <a:fld id="{F33174FD-3531-4AD8-AF7A-64487AF244F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454685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6" y="6"/>
            <a:ext cx="2949533" cy="497969"/>
          </a:xfrm>
          <a:prstGeom prst="rect">
            <a:avLst/>
          </a:prstGeom>
        </p:spPr>
        <p:txBody>
          <a:bodyPr vert="horz" lIns="88255" tIns="44127" rIns="88255" bIns="44127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146" y="6"/>
            <a:ext cx="2949532" cy="497969"/>
          </a:xfrm>
          <a:prstGeom prst="rect">
            <a:avLst/>
          </a:prstGeom>
        </p:spPr>
        <p:txBody>
          <a:bodyPr vert="horz" lIns="88255" tIns="44127" rIns="88255" bIns="44127" rtlCol="0"/>
          <a:lstStyle>
            <a:lvl1pPr algn="r">
              <a:defRPr sz="1200"/>
            </a:lvl1pPr>
          </a:lstStyle>
          <a:p>
            <a:fld id="{967D371C-0BC3-47E7-8070-1D8FD1977CE7}" type="datetimeFigureOut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9988" y="1243013"/>
            <a:ext cx="447040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8255" tIns="44127" rIns="88255" bIns="44127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480" y="4783900"/>
            <a:ext cx="5445760" cy="3912834"/>
          </a:xfrm>
          <a:prstGeom prst="rect">
            <a:avLst/>
          </a:prstGeom>
        </p:spPr>
        <p:txBody>
          <a:bodyPr vert="horz" lIns="88255" tIns="44127" rIns="88255" bIns="44127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6" y="9441374"/>
            <a:ext cx="2949533" cy="497969"/>
          </a:xfrm>
          <a:prstGeom prst="rect">
            <a:avLst/>
          </a:prstGeom>
        </p:spPr>
        <p:txBody>
          <a:bodyPr vert="horz" lIns="88255" tIns="44127" rIns="88255" bIns="44127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146" y="9441374"/>
            <a:ext cx="2949532" cy="497969"/>
          </a:xfrm>
          <a:prstGeom prst="rect">
            <a:avLst/>
          </a:prstGeom>
        </p:spPr>
        <p:txBody>
          <a:bodyPr vert="horz" lIns="88255" tIns="44127" rIns="88255" bIns="44127" rtlCol="0" anchor="b"/>
          <a:lstStyle>
            <a:lvl1pPr algn="r">
              <a:defRPr sz="1200"/>
            </a:lvl1pPr>
          </a:lstStyle>
          <a:p>
            <a:fld id="{8087B928-A29C-4023-B70B-14035D670E3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995196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34DCA-D378-4CBA-B2EB-93C479760CB0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91631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BCBA4-CF1C-4256-B860-9AA9E7FB8F04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54079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E0B85-B1A1-420B-8C58-5608326397E3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22792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5F2AD-7792-4694-8A8D-47038094A2F6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786931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3A5AA-51B3-4289-92E7-56B34844DC67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32433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D8A87-828D-49E8-A499-33D151351DDD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57634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88CF2-512A-43F6-A490-B679F1114C95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28328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7687B-7EE4-45EB-8EF6-70E0D13ADE99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96728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E90B6-349F-44D5-A782-8BAC83707F4E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42946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95BB9-420E-4F1B-9995-3D589F84EF36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61817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dirty="0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4C5CE-5E4E-41FD-8680-1EA160B04991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3225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73DC1-41A9-4AF1-8DBE-785BCAA55A2A}" type="datetime1">
              <a:rPr kumimoji="1" lang="ja-JP" altLang="en-US" smtClean="0"/>
              <a:t>2019/9/30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89310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正方形/長方形 9"/>
          <p:cNvSpPr/>
          <p:nvPr/>
        </p:nvSpPr>
        <p:spPr>
          <a:xfrm>
            <a:off x="263954" y="531364"/>
            <a:ext cx="860988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e</a:t>
            </a:r>
            <a:r>
              <a:rPr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E observed in safety assessment of  the GMA therapy in the five major special situation sub-groups</a:t>
            </a:r>
          </a:p>
        </p:txBody>
      </p:sp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2455823"/>
              </p:ext>
            </p:extLst>
          </p:nvPr>
        </p:nvGraphicFramePr>
        <p:xfrm>
          <a:off x="350928" y="785076"/>
          <a:ext cx="8144143" cy="5333431"/>
        </p:xfrm>
        <a:graphic>
          <a:graphicData uri="http://schemas.openxmlformats.org/drawingml/2006/table">
            <a:tbl>
              <a:tblPr/>
              <a:tblGrid>
                <a:gridCol w="2343111"/>
                <a:gridCol w="412955"/>
                <a:gridCol w="491613"/>
                <a:gridCol w="648929"/>
                <a:gridCol w="619432"/>
                <a:gridCol w="550606"/>
                <a:gridCol w="540775"/>
                <a:gridCol w="639096"/>
                <a:gridCol w="580103"/>
                <a:gridCol w="580104"/>
                <a:gridCol w="737419"/>
              </a:tblGrid>
              <a:tr h="52391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Observation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atients who</a:t>
                      </a:r>
                    </a:p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eceived</a:t>
                      </a:r>
                      <a:r>
                        <a:rPr lang="ja-JP" altLang="en-US" sz="10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GMA retreatmen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atients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on multiple</a:t>
                      </a:r>
                    </a:p>
                    <a:p>
                      <a:pPr algn="ctr" fontAlgn="ctr"/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immunosuppressant</a:t>
                      </a:r>
                    </a:p>
                    <a:p>
                      <a:pPr algn="ctr" fontAlgn="ctr"/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medication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Elderly patients</a:t>
                      </a:r>
                    </a:p>
                    <a:p>
                      <a:pPr algn="ctr" fontAlgn="ctr"/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ja-JP" alt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≥</a:t>
                      </a: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65 years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atients with </a:t>
                      </a:r>
                    </a:p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naemia</a:t>
                      </a:r>
                    </a:p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haemoglobin </a:t>
                      </a:r>
                    </a:p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&lt;10 g/dL</a:t>
                      </a: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aediatric/adolescent</a:t>
                      </a:r>
                    </a:p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atients</a:t>
                      </a:r>
                    </a:p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 (≤18 years)</a:t>
                      </a: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otal number and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%)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of patients with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.9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5.2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1.2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8.1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8.9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umber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(%) </a:t>
                      </a: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of patients with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: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ever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6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9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hill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0%)</a:t>
                      </a: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Nausea/Vomiting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.6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.7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bdominal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discomfort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6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altLang="ja-JP" sz="10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0%)</a:t>
                      </a: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Headache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.2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eripheral neuropathy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0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9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bnormal liver function test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6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0%)</a:t>
                      </a:r>
                      <a:endParaRPr lang="en-US" altLang="ja-JP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9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Dysphoria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6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0%)</a:t>
                      </a:r>
                      <a:endParaRPr lang="en-US" altLang="ja-JP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9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anic disorder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0%)</a:t>
                      </a:r>
                      <a:endParaRPr lang="en-US" altLang="ja-JP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Sepsis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.4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9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yelonephritis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9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ommon col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0%)</a:t>
                      </a: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atheter-related infection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9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Disseminated intravascular coagulation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6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ebrile neutropenia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ancytopenia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en-US" altLang="ja-JP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0%)</a:t>
                      </a: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spiration pneumonitis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en-US" altLang="ja-JP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Oropharyngeal discomfort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Hypoxia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0%)</a:t>
                      </a: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Low back pain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oxitis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0%)</a:t>
                      </a: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Hypotension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9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hromboembolic event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0%)</a:t>
                      </a: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alpitation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trial fibrillation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0%)</a:t>
                      </a: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Drug hypersensitivity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6%)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  <a:tr h="1625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Bile duct stone</a:t>
                      </a:r>
                    </a:p>
                  </a:txBody>
                  <a:tcPr marL="9011" marR="9011" marT="9011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.0%)</a:t>
                      </a: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/>
                      <a:r>
                        <a:rPr lang="en-US" altLang="ja-JP" sz="1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011" marR="9011" marT="901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" name="正方形/長方形 3"/>
          <p:cNvSpPr/>
          <p:nvPr/>
        </p:nvSpPr>
        <p:spPr>
          <a:xfrm>
            <a:off x="263954" y="6081017"/>
            <a:ext cx="705956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E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verse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vent, </a:t>
            </a:r>
            <a:r>
              <a:rPr lang="en-US" altLang="ja-JP" sz="1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MA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nulocyte and monocyte adsorptive </a:t>
            </a:r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heresis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44003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41</TotalTime>
  <Words>487</Words>
  <Application>Microsoft Office PowerPoint</Application>
  <PresentationFormat>画面に合わせる (4:3)</PresentationFormat>
  <Paragraphs>25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>JIMR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kuma Seiichiro（国馬 誠一郎）</dc:creator>
  <cp:lastModifiedBy>hosoi eiji（細井　栄治）</cp:lastModifiedBy>
  <cp:revision>1017</cp:revision>
  <cp:lastPrinted>2018-11-09T05:42:12Z</cp:lastPrinted>
  <dcterms:created xsi:type="dcterms:W3CDTF">2017-02-06T05:38:59Z</dcterms:created>
  <dcterms:modified xsi:type="dcterms:W3CDTF">2019-09-30T05:04:38Z</dcterms:modified>
</cp:coreProperties>
</file>